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9144000" cy="6858000" type="screen4x3"/>
  <p:notesSz cx="6648450" cy="9774238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777777"/>
    <a:srgbClr val="292929"/>
    <a:srgbClr val="5F5F5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9" d="100"/>
          <a:sy n="69" d="100"/>
        </p:scale>
        <p:origin x="-594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73F742-1CD5-47E4-82C4-C3A02B32AF74}" type="datetimeFigureOut">
              <a:rPr lang="de-DE" smtClean="0"/>
              <a:t>24.03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8E4DCD-1E94-4AFD-96DC-833668FF254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904256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73F742-1CD5-47E4-82C4-C3A02B32AF74}" type="datetimeFigureOut">
              <a:rPr lang="de-DE" smtClean="0"/>
              <a:t>24.03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8E4DCD-1E94-4AFD-96DC-833668FF254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537558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73F742-1CD5-47E4-82C4-C3A02B32AF74}" type="datetimeFigureOut">
              <a:rPr lang="de-DE" smtClean="0"/>
              <a:t>24.03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8E4DCD-1E94-4AFD-96DC-833668FF254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072039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73F742-1CD5-47E4-82C4-C3A02B32AF74}" type="datetimeFigureOut">
              <a:rPr lang="de-DE" smtClean="0"/>
              <a:t>24.03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8E4DCD-1E94-4AFD-96DC-833668FF254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372811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73F742-1CD5-47E4-82C4-C3A02B32AF74}" type="datetimeFigureOut">
              <a:rPr lang="de-DE" smtClean="0"/>
              <a:t>24.03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8E4DCD-1E94-4AFD-96DC-833668FF254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274160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73F742-1CD5-47E4-82C4-C3A02B32AF74}" type="datetimeFigureOut">
              <a:rPr lang="de-DE" smtClean="0"/>
              <a:t>24.03.2019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8E4DCD-1E94-4AFD-96DC-833668FF254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765229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73F742-1CD5-47E4-82C4-C3A02B32AF74}" type="datetimeFigureOut">
              <a:rPr lang="de-DE" smtClean="0"/>
              <a:t>24.03.2019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8E4DCD-1E94-4AFD-96DC-833668FF254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59366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73F742-1CD5-47E4-82C4-C3A02B32AF74}" type="datetimeFigureOut">
              <a:rPr lang="de-DE" smtClean="0"/>
              <a:t>24.03.2019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8E4DCD-1E94-4AFD-96DC-833668FF254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58019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73F742-1CD5-47E4-82C4-C3A02B32AF74}" type="datetimeFigureOut">
              <a:rPr lang="de-DE" smtClean="0"/>
              <a:t>24.03.2019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8E4DCD-1E94-4AFD-96DC-833668FF254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045362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73F742-1CD5-47E4-82C4-C3A02B32AF74}" type="datetimeFigureOut">
              <a:rPr lang="de-DE" smtClean="0"/>
              <a:t>24.03.2019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8E4DCD-1E94-4AFD-96DC-833668FF254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637910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73F742-1CD5-47E4-82C4-C3A02B32AF74}" type="datetimeFigureOut">
              <a:rPr lang="de-DE" smtClean="0"/>
              <a:t>24.03.2019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8E4DCD-1E94-4AFD-96DC-833668FF254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479188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73F742-1CD5-47E4-82C4-C3A02B32AF74}" type="datetimeFigureOut">
              <a:rPr lang="de-DE" smtClean="0"/>
              <a:t>24.03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8E4DCD-1E94-4AFD-96DC-833668FF254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420289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feld 9"/>
          <p:cNvSpPr txBox="1"/>
          <p:nvPr/>
        </p:nvSpPr>
        <p:spPr>
          <a:xfrm>
            <a:off x="6189247" y="1326285"/>
            <a:ext cx="2253600" cy="36933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>
            <a:noAutofit/>
          </a:bodyPr>
          <a:lstStyle/>
          <a:p>
            <a:pPr algn="ctr"/>
            <a:r>
              <a:rPr lang="de-DE" sz="1700" dirty="0" smtClean="0">
                <a:latin typeface="Arial" panose="020B0604020202020204" pitchFamily="34" charset="0"/>
                <a:cs typeface="Arial" panose="020B0604020202020204" pitchFamily="34" charset="0"/>
              </a:rPr>
              <a:t>LCA  </a:t>
            </a:r>
            <a:r>
              <a:rPr lang="de-DE" sz="1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riterion</a:t>
            </a:r>
            <a:r>
              <a:rPr lang="de-DE" sz="17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PL</a:t>
            </a:r>
            <a:endParaRPr lang="de-DE" sz="1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8" name="Gewinkelte Verbindung 27"/>
          <p:cNvCxnSpPr>
            <a:stCxn id="10" idx="3"/>
            <a:endCxn id="26" idx="3"/>
          </p:cNvCxnSpPr>
          <p:nvPr/>
        </p:nvCxnSpPr>
        <p:spPr>
          <a:xfrm flipH="1">
            <a:off x="5804620" y="1510951"/>
            <a:ext cx="2638227" cy="2218414"/>
          </a:xfrm>
          <a:prstGeom prst="bentConnector3">
            <a:avLst>
              <a:gd name="adj1" fmla="val -8665"/>
            </a:avLst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Rechteck 28"/>
          <p:cNvSpPr/>
          <p:nvPr/>
        </p:nvSpPr>
        <p:spPr>
          <a:xfrm>
            <a:off x="759781" y="4268878"/>
            <a:ext cx="5044839" cy="594054"/>
          </a:xfrm>
          <a:prstGeom prst="rect">
            <a:avLst/>
          </a:prstGeom>
          <a:solidFill>
            <a:schemeClr val="bg1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0" name="Textfeld 29"/>
          <p:cNvSpPr txBox="1"/>
          <p:nvPr/>
        </p:nvSpPr>
        <p:spPr>
          <a:xfrm>
            <a:off x="856763" y="4381239"/>
            <a:ext cx="4765031" cy="369332"/>
          </a:xfrm>
          <a:prstGeom prst="rect">
            <a:avLst/>
          </a:prstGeom>
          <a:solidFill>
            <a:schemeClr val="bg1"/>
          </a:solidFill>
          <a:ln cmpd="dbl">
            <a:solidFill>
              <a:schemeClr val="tx1"/>
            </a:solidFill>
          </a:ln>
        </p:spPr>
        <p:txBody>
          <a:bodyPr wrap="square" rtlCol="0">
            <a:noAutofit/>
          </a:bodyPr>
          <a:lstStyle/>
          <a:p>
            <a:pPr algn="ctr"/>
            <a:r>
              <a:rPr lang="de-DE" sz="1700" b="1" dirty="0" err="1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de-DE" sz="17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nsitivities</a:t>
            </a:r>
            <a:r>
              <a:rPr lang="de-DE" sz="1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7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7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pecificities</a:t>
            </a:r>
            <a:endParaRPr lang="de-DE" sz="1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Rechteck 3"/>
          <p:cNvSpPr/>
          <p:nvPr/>
        </p:nvSpPr>
        <p:spPr>
          <a:xfrm>
            <a:off x="777082" y="377593"/>
            <a:ext cx="5027539" cy="281225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52" name="Rechteck 51"/>
          <p:cNvSpPr/>
          <p:nvPr/>
        </p:nvSpPr>
        <p:spPr>
          <a:xfrm>
            <a:off x="771314" y="5941957"/>
            <a:ext cx="5039074" cy="538451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5" name="Textfeld 4"/>
          <p:cNvSpPr txBox="1"/>
          <p:nvPr/>
        </p:nvSpPr>
        <p:spPr>
          <a:xfrm>
            <a:off x="899373" y="515589"/>
            <a:ext cx="2253600" cy="36933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>
            <a:noAutofit/>
          </a:bodyPr>
          <a:lstStyle/>
          <a:p>
            <a:pPr algn="ctr"/>
            <a:r>
              <a:rPr lang="de-DE" sz="1700" dirty="0" smtClean="0">
                <a:latin typeface="Arial" panose="020B0604020202020204" pitchFamily="34" charset="0"/>
                <a:cs typeface="Arial" panose="020B0604020202020204" pitchFamily="34" charset="0"/>
              </a:rPr>
              <a:t>ALE </a:t>
            </a:r>
            <a:r>
              <a:rPr lang="de-DE" sz="1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riterion</a:t>
            </a:r>
            <a:r>
              <a:rPr lang="de-DE" sz="17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PL</a:t>
            </a:r>
            <a:endParaRPr lang="de-DE" sz="1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feld 5"/>
          <p:cNvSpPr txBox="1"/>
          <p:nvPr/>
        </p:nvSpPr>
        <p:spPr>
          <a:xfrm>
            <a:off x="2133783" y="1599791"/>
            <a:ext cx="2253600" cy="36933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>
            <a:noAutofit/>
          </a:bodyPr>
          <a:lstStyle/>
          <a:p>
            <a:pPr algn="ctr"/>
            <a:r>
              <a:rPr lang="de-DE" sz="1700" dirty="0" smtClean="0">
                <a:latin typeface="Arial" panose="020B0604020202020204" pitchFamily="34" charset="0"/>
                <a:cs typeface="Arial" panose="020B0604020202020204" pitchFamily="34" charset="0"/>
              </a:rPr>
              <a:t>UNI  </a:t>
            </a:r>
            <a:r>
              <a:rPr lang="de-DE" sz="1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riterion</a:t>
            </a:r>
            <a:r>
              <a:rPr lang="de-DE" sz="17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PL</a:t>
            </a:r>
            <a:endParaRPr lang="de-DE" sz="1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feld 6"/>
          <p:cNvSpPr txBox="1"/>
          <p:nvPr/>
        </p:nvSpPr>
        <p:spPr>
          <a:xfrm>
            <a:off x="1516578" y="1057690"/>
            <a:ext cx="2253600" cy="36933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>
            <a:noAutofit/>
          </a:bodyPr>
          <a:lstStyle/>
          <a:p>
            <a:pPr algn="ctr"/>
            <a:r>
              <a:rPr lang="de-DE" sz="1700" dirty="0" smtClean="0">
                <a:latin typeface="Arial" panose="020B0604020202020204" pitchFamily="34" charset="0"/>
                <a:cs typeface="Arial" panose="020B0604020202020204" pitchFamily="34" charset="0"/>
              </a:rPr>
              <a:t>ACU </a:t>
            </a:r>
            <a:r>
              <a:rPr lang="de-DE" sz="1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riterion</a:t>
            </a:r>
            <a:r>
              <a:rPr lang="de-DE" sz="17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PL</a:t>
            </a:r>
            <a:endParaRPr lang="de-DE" sz="1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feld 7"/>
          <p:cNvSpPr txBox="1"/>
          <p:nvPr/>
        </p:nvSpPr>
        <p:spPr>
          <a:xfrm>
            <a:off x="2750988" y="2141892"/>
            <a:ext cx="2253600" cy="36933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>
            <a:noAutofit/>
          </a:bodyPr>
          <a:lstStyle/>
          <a:p>
            <a:pPr algn="ctr"/>
            <a:r>
              <a:rPr lang="de-DE" sz="1700" dirty="0" smtClean="0">
                <a:latin typeface="Arial" panose="020B0604020202020204" pitchFamily="34" charset="0"/>
                <a:cs typeface="Arial" panose="020B0604020202020204" pitchFamily="34" charset="0"/>
              </a:rPr>
              <a:t>AES  </a:t>
            </a:r>
            <a:r>
              <a:rPr lang="de-DE" sz="1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riterion</a:t>
            </a:r>
            <a:r>
              <a:rPr lang="de-DE" sz="17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PL</a:t>
            </a:r>
            <a:endParaRPr lang="de-DE" sz="1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feld 8"/>
          <p:cNvSpPr txBox="1"/>
          <p:nvPr/>
        </p:nvSpPr>
        <p:spPr>
          <a:xfrm>
            <a:off x="3368194" y="2682524"/>
            <a:ext cx="2253600" cy="36933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noAutofit/>
          </a:bodyPr>
          <a:lstStyle/>
          <a:p>
            <a:pPr algn="ctr"/>
            <a:r>
              <a:rPr lang="de-DE" sz="1700" dirty="0" smtClean="0">
                <a:latin typeface="Arial" panose="020B0604020202020204" pitchFamily="34" charset="0"/>
                <a:cs typeface="Arial" panose="020B0604020202020204" pitchFamily="34" charset="0"/>
              </a:rPr>
              <a:t>LIA </a:t>
            </a:r>
            <a:r>
              <a:rPr lang="de-DE" sz="1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riterion</a:t>
            </a:r>
            <a:r>
              <a:rPr lang="de-DE" sz="17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PL</a:t>
            </a:r>
            <a:endParaRPr lang="de-DE" sz="1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feld 52"/>
          <p:cNvSpPr txBox="1"/>
          <p:nvPr/>
        </p:nvSpPr>
        <p:spPr>
          <a:xfrm>
            <a:off x="899373" y="6026516"/>
            <a:ext cx="2252603" cy="36933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>
            <a:noAutofit/>
          </a:bodyPr>
          <a:lstStyle/>
          <a:p>
            <a:pPr algn="ctr"/>
            <a:r>
              <a:rPr lang="de-DE" sz="1700" dirty="0" smtClean="0">
                <a:latin typeface="Arial" panose="020B0604020202020204" pitchFamily="34" charset="0"/>
                <a:cs typeface="Arial" panose="020B0604020202020204" pitchFamily="34" charset="0"/>
              </a:rPr>
              <a:t>AES non-</a:t>
            </a:r>
            <a:r>
              <a:rPr lang="de-DE" sz="1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riterion</a:t>
            </a:r>
            <a:r>
              <a:rPr lang="de-DE" sz="17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PL</a:t>
            </a:r>
            <a:endParaRPr lang="de-DE" sz="1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feld 53"/>
          <p:cNvSpPr txBox="1"/>
          <p:nvPr/>
        </p:nvSpPr>
        <p:spPr>
          <a:xfrm>
            <a:off x="3368194" y="6026516"/>
            <a:ext cx="2253600" cy="36933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noAutofit/>
          </a:bodyPr>
          <a:lstStyle/>
          <a:p>
            <a:pPr algn="ctr"/>
            <a:r>
              <a:rPr lang="de-DE" sz="1700" dirty="0" smtClean="0">
                <a:latin typeface="Arial" panose="020B0604020202020204" pitchFamily="34" charset="0"/>
                <a:cs typeface="Arial" panose="020B0604020202020204" pitchFamily="34" charset="0"/>
              </a:rPr>
              <a:t>LIA </a:t>
            </a:r>
            <a:r>
              <a:rPr lang="de-DE" sz="1700" dirty="0" smtClean="0">
                <a:latin typeface="Arial" panose="020B0604020202020204" pitchFamily="34" charset="0"/>
                <a:cs typeface="Arial" panose="020B0604020202020204" pitchFamily="34" charset="0"/>
              </a:rPr>
              <a:t>non-</a:t>
            </a:r>
            <a:r>
              <a:rPr lang="de-DE" sz="1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riterion</a:t>
            </a:r>
            <a:r>
              <a:rPr lang="de-DE" sz="17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PL</a:t>
            </a:r>
            <a:endParaRPr lang="de-DE" sz="1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" name="Gewinkelte Verbindung 22"/>
          <p:cNvCxnSpPr>
            <a:stCxn id="7" idx="3"/>
          </p:cNvCxnSpPr>
          <p:nvPr/>
        </p:nvCxnSpPr>
        <p:spPr>
          <a:xfrm>
            <a:off x="3770178" y="1242356"/>
            <a:ext cx="2419069" cy="148294"/>
          </a:xfrm>
          <a:prstGeom prst="bentConnector3">
            <a:avLst>
              <a:gd name="adj1" fmla="val 62600"/>
            </a:avLst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Gewinkelte Verbindung 26"/>
          <p:cNvCxnSpPr>
            <a:stCxn id="6" idx="3"/>
          </p:cNvCxnSpPr>
          <p:nvPr/>
        </p:nvCxnSpPr>
        <p:spPr>
          <a:xfrm flipV="1">
            <a:off x="4387383" y="1633538"/>
            <a:ext cx="1801864" cy="150919"/>
          </a:xfrm>
          <a:prstGeom prst="bentConnector3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Gerade Verbindung mit Pfeil 37"/>
          <p:cNvCxnSpPr/>
          <p:nvPr/>
        </p:nvCxnSpPr>
        <p:spPr>
          <a:xfrm>
            <a:off x="1109211" y="884921"/>
            <a:ext cx="0" cy="3383957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Gerade Verbindung mit Pfeil 46"/>
          <p:cNvCxnSpPr/>
          <p:nvPr/>
        </p:nvCxnSpPr>
        <p:spPr>
          <a:xfrm>
            <a:off x="2313597" y="1981213"/>
            <a:ext cx="0" cy="2287665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Gerade Verbindung mit Pfeil 49"/>
          <p:cNvCxnSpPr/>
          <p:nvPr/>
        </p:nvCxnSpPr>
        <p:spPr>
          <a:xfrm>
            <a:off x="2915790" y="2511224"/>
            <a:ext cx="0" cy="1757654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Gerade Verbindung mit Pfeil 54"/>
          <p:cNvCxnSpPr/>
          <p:nvPr/>
        </p:nvCxnSpPr>
        <p:spPr>
          <a:xfrm>
            <a:off x="3517983" y="3051856"/>
            <a:ext cx="0" cy="1217022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Gerade Verbindung mit Pfeil 58"/>
          <p:cNvCxnSpPr/>
          <p:nvPr/>
        </p:nvCxnSpPr>
        <p:spPr>
          <a:xfrm>
            <a:off x="1711404" y="1427022"/>
            <a:ext cx="0" cy="2841856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feld 25"/>
          <p:cNvSpPr txBox="1"/>
          <p:nvPr/>
        </p:nvSpPr>
        <p:spPr>
          <a:xfrm>
            <a:off x="782848" y="3544699"/>
            <a:ext cx="5021772" cy="36933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noAutofit/>
          </a:bodyPr>
          <a:lstStyle/>
          <a:p>
            <a:pPr algn="ctr"/>
            <a:r>
              <a:rPr lang="de-DE" sz="1700" dirty="0" smtClean="0">
                <a:latin typeface="Arial" panose="020B0604020202020204" pitchFamily="34" charset="0"/>
                <a:cs typeface="Arial" panose="020B0604020202020204" pitchFamily="34" charset="0"/>
              </a:rPr>
              <a:t>„</a:t>
            </a:r>
            <a:r>
              <a:rPr lang="de-DE" sz="1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old</a:t>
            </a:r>
            <a:r>
              <a:rPr lang="de-DE" sz="17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tandard</a:t>
            </a:r>
            <a:r>
              <a:rPr lang="de-DE" sz="1700" dirty="0" smtClean="0">
                <a:latin typeface="Arial" panose="020B0604020202020204" pitchFamily="34" charset="0"/>
                <a:cs typeface="Arial" panose="020B0604020202020204" pitchFamily="34" charset="0"/>
              </a:rPr>
              <a:t>“ </a:t>
            </a:r>
            <a:r>
              <a:rPr lang="de-DE" sz="1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riterion</a:t>
            </a:r>
            <a:r>
              <a:rPr lang="de-DE" sz="17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PL</a:t>
            </a:r>
            <a:endParaRPr lang="de-DE" sz="1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3" name="Gerade Verbindung mit Pfeil 62"/>
          <p:cNvCxnSpPr>
            <a:stCxn id="54" idx="0"/>
          </p:cNvCxnSpPr>
          <p:nvPr/>
        </p:nvCxnSpPr>
        <p:spPr>
          <a:xfrm flipV="1">
            <a:off x="4494994" y="4864472"/>
            <a:ext cx="0" cy="1162044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Gerade Verbindung mit Pfeil 68"/>
          <p:cNvCxnSpPr>
            <a:stCxn id="53" idx="0"/>
          </p:cNvCxnSpPr>
          <p:nvPr/>
        </p:nvCxnSpPr>
        <p:spPr>
          <a:xfrm flipV="1">
            <a:off x="2025675" y="4864472"/>
            <a:ext cx="0" cy="1162044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feld 48"/>
          <p:cNvSpPr txBox="1"/>
          <p:nvPr/>
        </p:nvSpPr>
        <p:spPr>
          <a:xfrm>
            <a:off x="748246" y="5217779"/>
            <a:ext cx="5056375" cy="36933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noAutofit/>
          </a:bodyPr>
          <a:lstStyle/>
          <a:p>
            <a:pPr algn="ctr"/>
            <a:r>
              <a:rPr lang="de-DE" sz="1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linical</a:t>
            </a:r>
            <a:r>
              <a:rPr lang="de-DE" sz="17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iagnosis</a:t>
            </a:r>
            <a:endParaRPr lang="de-DE" sz="1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" name="Gewinkelte Verbindung 16"/>
          <p:cNvCxnSpPr>
            <a:stCxn id="5" idx="3"/>
            <a:endCxn id="10" idx="0"/>
          </p:cNvCxnSpPr>
          <p:nvPr/>
        </p:nvCxnSpPr>
        <p:spPr>
          <a:xfrm>
            <a:off x="3152973" y="700255"/>
            <a:ext cx="4163074" cy="626030"/>
          </a:xfrm>
          <a:prstGeom prst="bentConnector2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Gewinkelte Verbindung 24"/>
          <p:cNvCxnSpPr>
            <a:stCxn id="8" idx="3"/>
            <a:endCxn id="10" idx="2"/>
          </p:cNvCxnSpPr>
          <p:nvPr/>
        </p:nvCxnSpPr>
        <p:spPr>
          <a:xfrm flipV="1">
            <a:off x="5004588" y="1695617"/>
            <a:ext cx="2311459" cy="630941"/>
          </a:xfrm>
          <a:prstGeom prst="bentConnector2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275817643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5</Words>
  <Application>Microsoft Office PowerPoint</Application>
  <PresentationFormat>Bildschirmpräsentation (4:3)</PresentationFormat>
  <Paragraphs>11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Company>Lenovo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Lenovo User</dc:creator>
  <cp:lastModifiedBy>Lenovo User</cp:lastModifiedBy>
  <cp:revision>60</cp:revision>
  <cp:lastPrinted>2017-12-20T11:10:01Z</cp:lastPrinted>
  <dcterms:created xsi:type="dcterms:W3CDTF">2015-02-16T17:41:20Z</dcterms:created>
  <dcterms:modified xsi:type="dcterms:W3CDTF">2019-03-24T16:18:28Z</dcterms:modified>
</cp:coreProperties>
</file>